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6" r:id="rId2"/>
    <p:sldId id="257" r:id="rId3"/>
    <p:sldId id="259" r:id="rId4"/>
    <p:sldId id="260" r:id="rId5"/>
    <p:sldId id="261" r:id="rId6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49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b-NO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6EBE54-2C8B-46BF-9755-57A9B7A0DFD9}" type="datetimeFigureOut">
              <a:rPr lang="nb-NO" smtClean="0"/>
              <a:t>29.01.2023</a:t>
            </a:fld>
            <a:endParaRPr lang="nb-NO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b-NO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631C50-4203-493F-9AA4-AACCAA524EF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9069280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5. Heat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ap illustrating hierarchical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lusterering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of 10 differentially expressed proteins among the pulmonary tuberculosis patients' PMNCs samples at baseline "0M" (n=8), 2 months "2M" (n=7), and 6 months "6M" (n=6) using data from the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ienear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mixed model analysis. Each row represents a single protein. The columns depict the expression levels of individual samples. The color intensity of each panel is proportional to the relative intensities of the proteins; higher intensities are associated with red and lower intensities with green.</a:t>
            </a:r>
            <a:endParaRPr lang="nb-NO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nb-NO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AE85FD5-62FC-4A7A-840F-68B64B2E9738}" type="slidenum">
              <a:rPr lang="nb-NO" smtClean="0"/>
              <a:t>5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8856292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7D2C9F-A264-44B7-B19F-BE337C8F81D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A20C32D-29FB-41EE-BECB-B9840C2C3B0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C989D1-28AB-43B1-A1E6-C86B6FDB65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839E3-7A0F-4C73-94D9-81290635D21E}" type="datetimeFigureOut">
              <a:rPr lang="nb-NO" smtClean="0"/>
              <a:t>29.01.2023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F4B005-144D-45F4-ABBD-7F2E7CB66D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DC047D-CBDC-414E-93E9-A540312228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3C5B99-0528-48D6-82AD-DD0FFB63B6F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2007047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2E2F44-A8B5-4A91-B71C-60514BE7AC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16D58E0-673B-442D-87CC-6E6BA5EEA2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85CCA5-79B5-4389-B300-0200BCD13D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839E3-7A0F-4C73-94D9-81290635D21E}" type="datetimeFigureOut">
              <a:rPr lang="nb-NO" smtClean="0"/>
              <a:t>29.01.2023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939888-5AF8-4BCE-A524-E469F77B55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B7BEAE-D8A1-4AC7-B80D-350861A6EF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3C5B99-0528-48D6-82AD-DD0FFB63B6F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2437526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927FB56-26AB-4963-AEB0-5E2EE080E12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63B6D34-6D81-4984-9366-C511B82193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8A3837-932D-4150-A706-7408F911BB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839E3-7A0F-4C73-94D9-81290635D21E}" type="datetimeFigureOut">
              <a:rPr lang="nb-NO" smtClean="0"/>
              <a:t>29.01.2023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AA1E9E-023A-4F1B-A9D0-3440C16F76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275970-34C7-43B1-A33F-5D9529E708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3C5B99-0528-48D6-82AD-DD0FFB63B6F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6008204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6550F8-B59F-4639-9F60-7F66186C4A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459D81-A91E-43B6-B89E-FB003D18C0A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023CA7-321C-4321-9E5C-DFC4D9A3B9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839E3-7A0F-4C73-94D9-81290635D21E}" type="datetimeFigureOut">
              <a:rPr lang="nb-NO" smtClean="0"/>
              <a:t>29.01.2023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468FB3-7C19-4DF5-8522-2BDD6669D9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A6E1E8-21FE-484F-91F6-AE81553BC1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3C5B99-0528-48D6-82AD-DD0FFB63B6F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9696933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A6BC5B-CE97-4919-A497-BEC3998D1F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B7242EB-F87E-4EF3-ADAC-1A3BAB5B64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8815A7-EBE3-4C78-B768-0C61CC61C9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839E3-7A0F-4C73-94D9-81290635D21E}" type="datetimeFigureOut">
              <a:rPr lang="nb-NO" smtClean="0"/>
              <a:t>29.01.2023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C4D56E-822D-4AA8-9A66-1CF81C357D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9939A6-59D8-42CA-BA08-FE8447D7A9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3C5B99-0528-48D6-82AD-DD0FFB63B6F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5390727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EB20CD-2CF8-4618-B3D0-7D61C6F83D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C89E7A4-1364-449B-BCD7-E88963836A6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CCB7E44-494E-4FC2-8D8E-5ABB0FB0D9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A76A964-1320-41E1-B5BE-101A60D448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839E3-7A0F-4C73-94D9-81290635D21E}" type="datetimeFigureOut">
              <a:rPr lang="nb-NO" smtClean="0"/>
              <a:t>29.01.2023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8F1358-35EE-4586-BEEB-ED544457F5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00A421-12E4-45B3-87B7-03698C7EB2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3C5B99-0528-48D6-82AD-DD0FFB63B6F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5838991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75046C-9E36-4100-B9E1-30C017A292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FBD87E-3B46-46DC-BDE5-DB3296A7DB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4EEB326-AF64-4E31-9794-12E6F256EB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9052508-971F-49BE-A7A9-8F4FFC8ABAD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6A8564E-2411-400C-8A46-CAD8632A6B2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41868FC-6FD4-472D-B0C6-2486EB93EF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839E3-7A0F-4C73-94D9-81290635D21E}" type="datetimeFigureOut">
              <a:rPr lang="nb-NO" smtClean="0"/>
              <a:t>29.01.2023</a:t>
            </a:fld>
            <a:endParaRPr lang="nb-NO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9210275-D7A6-4B2F-9106-1346AF24DB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A51EDEF-181C-4F37-A035-BCD7729969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3C5B99-0528-48D6-82AD-DD0FFB63B6F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1806101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888FA8-EDB0-44EC-87B2-2E5849969D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885279C-55EE-482D-9A43-0DD7FBCC9C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839E3-7A0F-4C73-94D9-81290635D21E}" type="datetimeFigureOut">
              <a:rPr lang="nb-NO" smtClean="0"/>
              <a:t>29.01.2023</a:t>
            </a:fld>
            <a:endParaRPr lang="nb-NO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F820FC0-C211-468B-8C9B-C50CCDD032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4180989-F6B7-4B66-A504-AA144AEECF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3C5B99-0528-48D6-82AD-DD0FFB63B6F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3295696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A5760FD-1C9C-41D2-9B2C-406E73DE11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839E3-7A0F-4C73-94D9-81290635D21E}" type="datetimeFigureOut">
              <a:rPr lang="nb-NO" smtClean="0"/>
              <a:t>29.01.2023</a:t>
            </a:fld>
            <a:endParaRPr lang="nb-NO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7306EE4-8E0D-4F8C-A0BB-A83FFEB4CB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F304E35-EEA9-4CC4-A08D-9B710D4D6A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3C5B99-0528-48D6-82AD-DD0FFB63B6F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9651656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44D0FF-C334-4626-B10C-CAA521B2D7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6C4B9AE-4EB7-4CA8-AEA5-391A8BFB8F7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1E6A915-24C3-49EC-AA3B-43C24E737C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87455E-6B24-4FAF-B1B0-8CA47C1A1A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839E3-7A0F-4C73-94D9-81290635D21E}" type="datetimeFigureOut">
              <a:rPr lang="nb-NO" smtClean="0"/>
              <a:t>29.01.2023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527F91-3696-47BA-BE5F-9F6741538E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2E728BE-A7AC-42B8-ABE2-AD0FF476EA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3C5B99-0528-48D6-82AD-DD0FFB63B6F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8030252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C5DD45-FD41-4E7A-BBF8-286794C4C8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886551A-C8AA-41BA-BF0A-6752F191FE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376318-4872-4308-8D8F-1C89FFEEC5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6387769-8DCD-431D-B5D6-9BE99968CA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839E3-7A0F-4C73-94D9-81290635D21E}" type="datetimeFigureOut">
              <a:rPr lang="nb-NO" smtClean="0"/>
              <a:t>29.01.2023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600DC5D-3423-4C83-A048-3C7B368037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70F41D4-B020-48A2-961E-E803A55C36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3C5B99-0528-48D6-82AD-DD0FFB63B6F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7191462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623FED9-F7AD-4114-BFE3-C544A0A6E2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B19972E-0F45-47B6-A833-5E1B94E71C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BE7EE3-6368-4367-80C4-3514DD7FA5E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A839E3-7A0F-4C73-94D9-81290635D21E}" type="datetimeFigureOut">
              <a:rPr lang="nb-NO" smtClean="0"/>
              <a:t>29.01.2023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D4B75F-0284-4341-AE0F-2478CCEAFDA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D15B02-BCAC-4D6D-A98F-84423F8DEE9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3C5B99-0528-48D6-82AD-DD0FFB63B6F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8490798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Chart&#10;&#10;Description automatically generated">
            <a:extLst>
              <a:ext uri="{FF2B5EF4-FFF2-40B4-BE49-F238E27FC236}">
                <a16:creationId xmlns:a16="http://schemas.microsoft.com/office/drawing/2014/main" id="{C8E44688-B1E9-4AE0-9479-855114FBB1C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8024" y="124882"/>
            <a:ext cx="3651380" cy="561919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384B5DF0-3D55-4725-9E28-6DE8E18B0103}"/>
              </a:ext>
            </a:extLst>
          </p:cNvPr>
          <p:cNvSpPr txBox="1"/>
          <p:nvPr/>
        </p:nvSpPr>
        <p:spPr>
          <a:xfrm>
            <a:off x="508561" y="5902121"/>
            <a:ext cx="460033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1 Figure. Unsupervised hierarchical clustering of all samples.  All samples were clustered based on log2 transformed and z-scored LFQ values using Euclidean distance and average linkage in Perseus. The bar is representing z-scores</a:t>
            </a:r>
            <a:endParaRPr lang="nb-NO" sz="1200" dirty="0"/>
          </a:p>
        </p:txBody>
      </p:sp>
    </p:spTree>
    <p:extLst>
      <p:ext uri="{BB962C8B-B14F-4D97-AF65-F5344CB8AC3E}">
        <p14:creationId xmlns:p14="http://schemas.microsoft.com/office/powerpoint/2010/main" val="14806181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D8265C5-E988-4CF9-B088-E4AEC274AA87}"/>
              </a:ext>
            </a:extLst>
          </p:cNvPr>
          <p:cNvSpPr txBox="1"/>
          <p:nvPr/>
        </p:nvSpPr>
        <p:spPr>
          <a:xfrm>
            <a:off x="266307" y="5816224"/>
            <a:ext cx="475655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2 Figure. Clustering of Pearson correlation values.  LFQ values were used to perform a Pearson correlation of all samples.  The values were clustered using Euclidean distance and average linkage in Perseus. The bar is representing the Pearson correlation values. </a:t>
            </a:r>
            <a:endParaRPr lang="nb-NO" sz="1200" dirty="0"/>
          </a:p>
        </p:txBody>
      </p:sp>
      <p:pic>
        <p:nvPicPr>
          <p:cNvPr id="4" name="Picture 3" descr="Chart, bar chart&#10;&#10;Description automatically generated">
            <a:extLst>
              <a:ext uri="{FF2B5EF4-FFF2-40B4-BE49-F238E27FC236}">
                <a16:creationId xmlns:a16="http://schemas.microsoft.com/office/drawing/2014/main" id="{20F48C50-772D-4E85-A9E9-F55CC79663C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0283" y="671915"/>
            <a:ext cx="3344640" cy="50758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504810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diagram&#10;&#10;Description automatically generated">
            <a:extLst>
              <a:ext uri="{FF2B5EF4-FFF2-40B4-BE49-F238E27FC236}">
                <a16:creationId xmlns:a16="http://schemas.microsoft.com/office/drawing/2014/main" id="{81372BE5-C0F7-41E7-B4C4-429E13B17B7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427" y="587828"/>
            <a:ext cx="3684690" cy="495455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2B0D8CA-014D-47F7-B963-779DEB1DBB73}"/>
              </a:ext>
            </a:extLst>
          </p:cNvPr>
          <p:cNvSpPr txBox="1"/>
          <p:nvPr/>
        </p:nvSpPr>
        <p:spPr>
          <a:xfrm>
            <a:off x="465427" y="5710849"/>
            <a:ext cx="397234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srgbClr val="32313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3 Figure. Sample distribution of all samples</a:t>
            </a:r>
            <a:r>
              <a:rPr lang="en-GB" sz="1200" b="1" dirty="0">
                <a:solidFill>
                  <a:srgbClr val="32313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sz="1200" dirty="0">
                <a:solidFill>
                  <a:srgbClr val="32313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 histogram was made from each sample were the log2 LFQ intensity was plotted against counts.</a:t>
            </a:r>
            <a:endParaRPr lang="nb-NO" sz="12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nb-NO" sz="1200" dirty="0"/>
          </a:p>
        </p:txBody>
      </p:sp>
    </p:spTree>
    <p:extLst>
      <p:ext uri="{BB962C8B-B14F-4D97-AF65-F5344CB8AC3E}">
        <p14:creationId xmlns:p14="http://schemas.microsoft.com/office/powerpoint/2010/main" val="22520911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B9B4BFA-5ED2-4E1F-B753-486E5585C50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63471" y="192946"/>
            <a:ext cx="7497263" cy="4726619"/>
          </a:xfrm>
          <a:prstGeom prst="rect">
            <a:avLst/>
          </a:prstGeom>
        </p:spPr>
      </p:pic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8AC305B0-5DAB-4D4E-A0ED-343287EA69BC}"/>
              </a:ext>
            </a:extLst>
          </p:cNvPr>
          <p:cNvGraphicFramePr>
            <a:graphicFrameLocks noGrp="1"/>
          </p:cNvGraphicFramePr>
          <p:nvPr/>
        </p:nvGraphicFramePr>
        <p:xfrm>
          <a:off x="9865453" y="3419154"/>
          <a:ext cx="1219200" cy="261493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2484535347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335555566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nb-NO" sz="1100" u="none" strike="noStrike">
                          <a:effectLst/>
                        </a:rPr>
                        <a:t>Accession Key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1100" u="none" strike="noStrike">
                          <a:effectLst/>
                        </a:rPr>
                        <a:t>Gene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77476115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O94979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SEC31A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409259697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O95671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ASMTL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865782218"/>
                  </a:ext>
                </a:extLst>
              </a:tr>
              <a:tr h="374650"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P07900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HSP90AA1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529089469"/>
                  </a:ext>
                </a:extLst>
              </a:tr>
              <a:tr h="374650"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P0DMV9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HSPA1A, HSPA1B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34592338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P18428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LBP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09543658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Q7L1W4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LRRC8D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44649648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Q86VW0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SESTD1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51443979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Q92598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HSPH1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9100344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Q93099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HGD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4586669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Q9HB71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 dirty="0">
                          <a:effectLst/>
                        </a:rPr>
                        <a:t>CACYBP</a:t>
                      </a:r>
                      <a:endParaRPr lang="nb-NO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711342414"/>
                  </a:ext>
                </a:extLst>
              </a:tr>
            </a:tbl>
          </a:graphicData>
        </a:graphic>
      </p:graphicFrame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D2CC98C1-0858-4672-8740-500CD4E5BD87}"/>
              </a:ext>
            </a:extLst>
          </p:cNvPr>
          <p:cNvGraphicFramePr>
            <a:graphicFrameLocks noGrp="1"/>
          </p:cNvGraphicFramePr>
          <p:nvPr/>
        </p:nvGraphicFramePr>
        <p:xfrm>
          <a:off x="785730" y="3676534"/>
          <a:ext cx="2057400" cy="22733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79500">
                  <a:extLst>
                    <a:ext uri="{9D8B030D-6E8A-4147-A177-3AD203B41FA5}">
                      <a16:colId xmlns:a16="http://schemas.microsoft.com/office/drawing/2014/main" val="2129837636"/>
                    </a:ext>
                  </a:extLst>
                </a:gridCol>
                <a:gridCol w="977900">
                  <a:extLst>
                    <a:ext uri="{9D8B030D-6E8A-4147-A177-3AD203B41FA5}">
                      <a16:colId xmlns:a16="http://schemas.microsoft.com/office/drawing/2014/main" val="2318297435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nb-NO" sz="1100" u="none" strike="noStrike">
                          <a:effectLst/>
                        </a:rPr>
                        <a:t>Accession Key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1100" u="none" strike="noStrike">
                          <a:effectLst/>
                        </a:rPr>
                        <a:t>Gene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52120557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Q9Y259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CHKB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78133649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O95671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ASMTL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484692337"/>
                  </a:ext>
                </a:extLst>
              </a:tr>
              <a:tr h="374650"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O94979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SEC31A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608126182"/>
                  </a:ext>
                </a:extLst>
              </a:tr>
              <a:tr h="374650"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Q93099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HGD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75178271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P49588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AARS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86818649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Q7L1W4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LRRC8D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52140318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P08238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HSP90AB1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426128226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Q96HY6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DDRGK1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67556045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>
                          <a:effectLst/>
                        </a:rPr>
                        <a:t>P07900</a:t>
                      </a:r>
                      <a:endParaRPr lang="nb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u="none" strike="noStrike" dirty="0">
                          <a:effectLst/>
                        </a:rPr>
                        <a:t>HSP90AA1</a:t>
                      </a:r>
                      <a:endParaRPr lang="nb-NO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323089481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E01DC3F3-D0AC-982A-B3BE-B17CF3C4B6BA}"/>
              </a:ext>
            </a:extLst>
          </p:cNvPr>
          <p:cNvSpPr txBox="1"/>
          <p:nvPr/>
        </p:nvSpPr>
        <p:spPr>
          <a:xfrm>
            <a:off x="3547849" y="5526252"/>
            <a:ext cx="533792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srgbClr val="32313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4 Figure. Comparison of analysis for the differentially expressed proteins </a:t>
            </a:r>
            <a:r>
              <a:rPr lang="en-US" sz="1200" dirty="0">
                <a:solidFill>
                  <a:srgbClr val="32313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among the pulmonary tuberculosis patients' PMNCs samples by m</a:t>
            </a:r>
            <a:r>
              <a:rPr lang="en-US" sz="1200" dirty="0">
                <a:solidFill>
                  <a:srgbClr val="323130"/>
                </a:solidFill>
                <a:ea typeface="Times New Roman" panose="02020603050405020304" pitchFamily="18" charset="0"/>
              </a:rPr>
              <a:t>ixed linear model analysis with correction for multiple testing and ANOVA with correction for multiple testing</a:t>
            </a:r>
            <a:r>
              <a:rPr lang="en-US" sz="1200" dirty="0">
                <a:solidFill>
                  <a:srgbClr val="323130"/>
                </a:solidFill>
                <a:effectLst/>
                <a:ea typeface="Times New Roman" panose="02020603050405020304" pitchFamily="18" charset="0"/>
              </a:rPr>
              <a:t>. The mixed linear model shows the same trend as the multiple ANOVA test where 50% of the top 10 differentially expressed proteins overlap. </a:t>
            </a:r>
            <a:endParaRPr lang="nb-NO" sz="1200" dirty="0"/>
          </a:p>
        </p:txBody>
      </p:sp>
    </p:spTree>
    <p:extLst>
      <p:ext uri="{BB962C8B-B14F-4D97-AF65-F5344CB8AC3E}">
        <p14:creationId xmlns:p14="http://schemas.microsoft.com/office/powerpoint/2010/main" val="7159543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722F54AE-15F5-44BB-B623-91C558C4D6C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26524" y="5060167"/>
            <a:ext cx="5037510" cy="615982"/>
          </a:xfrm>
          <a:prstGeom prst="rect">
            <a:avLst/>
          </a:prstGeom>
        </p:spPr>
      </p:pic>
      <p:pic>
        <p:nvPicPr>
          <p:cNvPr id="14" name="Content Placeholder 13" descr="Graphical user interface&#10;&#10;Description automatically generated">
            <a:extLst>
              <a:ext uri="{FF2B5EF4-FFF2-40B4-BE49-F238E27FC236}">
                <a16:creationId xmlns:a16="http://schemas.microsoft.com/office/drawing/2014/main" id="{782FA014-CED6-4A97-85D8-92985A85538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33451" y="456975"/>
            <a:ext cx="5544070" cy="4351338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A2346D2-9F5F-C1F2-B5E8-763F7CC7B5B4}"/>
              </a:ext>
            </a:extLst>
          </p:cNvPr>
          <p:cNvSpPr txBox="1"/>
          <p:nvPr/>
        </p:nvSpPr>
        <p:spPr>
          <a:xfrm>
            <a:off x="1954689" y="5657671"/>
            <a:ext cx="710385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ea typeface="Calibri" panose="020F0502020204030204" pitchFamily="34" charset="0"/>
                <a:cs typeface="Arial" panose="020B0604020202020204" pitchFamily="34" charset="0"/>
              </a:rPr>
              <a:t>S5 Figure. </a:t>
            </a:r>
            <a:r>
              <a:rPr lang="en-US" sz="1200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Heat map illustrating hierarchical clustering of 10 differentially expressed proteins among the pulmonary tuberculosis patients' PMNCs samples at baseline "0M" (n=8), 2 months "2M" (n=7), and 6 months "6M" (n=6) using data from the linear mixed model analysis. Each row represents a single protein. The columns depict the expression levels of individual samples. The color intensity of each panel is proportional to the relative intensities of the proteins; higher intensities are associated with red and lower intensities with green.</a:t>
            </a:r>
            <a:endParaRPr lang="nb-NO" sz="1200" dirty="0">
              <a:effectLst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nb-NO" sz="1200" dirty="0"/>
          </a:p>
        </p:txBody>
      </p:sp>
    </p:spTree>
    <p:extLst>
      <p:ext uri="{BB962C8B-B14F-4D97-AF65-F5344CB8AC3E}">
        <p14:creationId xmlns:p14="http://schemas.microsoft.com/office/powerpoint/2010/main" val="8653548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9</TotalTime>
  <Words>427</Words>
  <Application>Microsoft Office PowerPoint</Application>
  <PresentationFormat>Widescreen</PresentationFormat>
  <Paragraphs>49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hmina Mustafa</dc:creator>
  <cp:lastModifiedBy>Tehmina Mustafa</cp:lastModifiedBy>
  <cp:revision>9</cp:revision>
  <dcterms:created xsi:type="dcterms:W3CDTF">2021-07-05T21:02:18Z</dcterms:created>
  <dcterms:modified xsi:type="dcterms:W3CDTF">2023-01-29T19:33:09Z</dcterms:modified>
</cp:coreProperties>
</file>